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6" autoAdjust="0"/>
    <p:restoredTop sz="94530" autoAdjust="0"/>
  </p:normalViewPr>
  <p:slideViewPr>
    <p:cSldViewPr>
      <p:cViewPr>
        <p:scale>
          <a:sx n="60" d="100"/>
          <a:sy n="60" d="100"/>
        </p:scale>
        <p:origin x="-1686" y="-28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7EB6E6-1B63-4D9E-912E-1DD412936FD7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697F41-13F5-4C7F-B067-4836EC3E9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252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S2: Comparison</a:t>
            </a:r>
            <a:r>
              <a:rPr lang="en-US" baseline="0" dirty="0" smtClean="0"/>
              <a:t> of invasive and CMR-derived pressure reading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697F41-13F5-4C7F-B067-4836EC3E9E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79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426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62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391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635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133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397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62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887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353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015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116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1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17867" y="-438281"/>
            <a:ext cx="5866027" cy="10222348"/>
            <a:chOff x="-877533" y="-372001"/>
            <a:chExt cx="5866027" cy="10222348"/>
          </a:xfrm>
        </p:grpSpPr>
        <p:grpSp>
          <p:nvGrpSpPr>
            <p:cNvPr id="3" name="Group 2"/>
            <p:cNvGrpSpPr/>
            <p:nvPr/>
          </p:nvGrpSpPr>
          <p:grpSpPr>
            <a:xfrm>
              <a:off x="-877533" y="-372001"/>
              <a:ext cx="5866027" cy="10180320"/>
              <a:chOff x="-579120" y="-350520"/>
              <a:chExt cx="5866027" cy="10180320"/>
            </a:xfrm>
            <a:effectLst/>
          </p:grpSpPr>
          <p:sp>
            <p:nvSpPr>
              <p:cNvPr id="2" name="Rectangle 1"/>
              <p:cNvSpPr/>
              <p:nvPr/>
            </p:nvSpPr>
            <p:spPr>
              <a:xfrm>
                <a:off x="-579120" y="-350520"/>
                <a:ext cx="5793041" cy="101803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3442" y="49914"/>
                <a:ext cx="2395867" cy="225318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31387" y="62828"/>
                <a:ext cx="2384121" cy="224213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34399" y="2430932"/>
                <a:ext cx="2432064" cy="228722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650335" y="1621681"/>
                <a:ext cx="1151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1</a:t>
                </a:r>
              </a:p>
              <a:p>
                <a:r>
                  <a:rPr lang="en-US" sz="1200" dirty="0" smtClean="0"/>
                  <a:t>r=0.77</a:t>
                </a:r>
                <a:endParaRPr lang="en-US" sz="12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135050" y="1661150"/>
                <a:ext cx="1151857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2</a:t>
                </a:r>
              </a:p>
              <a:p>
                <a:r>
                  <a:rPr lang="en-US" sz="1200" dirty="0" smtClean="0"/>
                  <a:t>r=0.94</a:t>
                </a:r>
              </a:p>
              <a:p>
                <a:endParaRPr lang="en-US" sz="12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22213" y="4068070"/>
                <a:ext cx="1151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3</a:t>
                </a:r>
              </a:p>
              <a:p>
                <a:r>
                  <a:rPr lang="en-US" sz="1200" dirty="0" smtClean="0"/>
                  <a:t>r=0.78</a:t>
                </a:r>
                <a:endParaRPr lang="en-US" sz="1200" dirty="0"/>
              </a:p>
            </p:txBody>
          </p:sp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12086" y="2485634"/>
                <a:ext cx="2403422" cy="226029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4119835" y="4068069"/>
                <a:ext cx="1151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4</a:t>
                </a:r>
              </a:p>
              <a:p>
                <a:r>
                  <a:rPr lang="en-US" sz="1200" dirty="0" smtClean="0"/>
                  <a:t>r=0.99</a:t>
                </a:r>
                <a:endParaRPr lang="en-US" sz="1200" dirty="0"/>
              </a:p>
            </p:txBody>
          </p:sp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28682" y="4835646"/>
                <a:ext cx="2382425" cy="22405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1441022" y="6417816"/>
                <a:ext cx="1151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5</a:t>
                </a:r>
              </a:p>
              <a:p>
                <a:r>
                  <a:rPr lang="en-US" sz="1200" dirty="0"/>
                  <a:t>r</a:t>
                </a:r>
                <a:r>
                  <a:rPr lang="en-US" sz="1200" dirty="0" smtClean="0"/>
                  <a:t>=0.89</a:t>
                </a:r>
                <a:endParaRPr lang="en-US" sz="1200" dirty="0"/>
              </a:p>
            </p:txBody>
          </p:sp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18647" y="4811860"/>
                <a:ext cx="2442581" cy="229711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4119811" y="6417816"/>
                <a:ext cx="1151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6</a:t>
                </a:r>
              </a:p>
              <a:p>
                <a:r>
                  <a:rPr lang="en-US" sz="1200" dirty="0"/>
                  <a:t>r</a:t>
                </a:r>
                <a:r>
                  <a:rPr lang="en-US" sz="1200" dirty="0" smtClean="0"/>
                  <a:t>=0.90</a:t>
                </a:r>
                <a:endParaRPr lang="en-US" sz="1200" dirty="0"/>
              </a:p>
            </p:txBody>
          </p:sp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3442" y="7182604"/>
                <a:ext cx="2382425" cy="224054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1428688" y="8703816"/>
                <a:ext cx="1151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7</a:t>
                </a:r>
              </a:p>
              <a:p>
                <a:r>
                  <a:rPr lang="en-US" sz="1200" dirty="0"/>
                  <a:t>r</a:t>
                </a:r>
                <a:r>
                  <a:rPr lang="en-US" sz="1200" dirty="0" smtClean="0"/>
                  <a:t>=0.87</a:t>
                </a:r>
                <a:endParaRPr lang="en-US" sz="1200" dirty="0"/>
              </a:p>
            </p:txBody>
          </p:sp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87731" y="7136884"/>
                <a:ext cx="2473498" cy="232619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4062064" y="8703816"/>
                <a:ext cx="11518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Patient 8</a:t>
                </a:r>
              </a:p>
              <a:p>
                <a:r>
                  <a:rPr lang="en-US" sz="1200" dirty="0"/>
                  <a:t>r</a:t>
                </a:r>
                <a:r>
                  <a:rPr lang="en-US" sz="1200" dirty="0" smtClean="0"/>
                  <a:t>=0.93</a:t>
                </a:r>
                <a:endParaRPr lang="en-US" sz="1200" dirty="0"/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>
              <a:off x="1220793" y="9573348"/>
              <a:ext cx="34420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Invasive pressure/mmHg</a:t>
              </a:r>
              <a:endParaRPr lang="en-US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-2412325" y="3093901"/>
              <a:ext cx="34366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CMR – derived pressure/mmHg</a:t>
              </a:r>
              <a:endParaRPr lang="en-US" sz="1200" dirty="0"/>
            </a:p>
          </p:txBody>
        </p:sp>
      </p:grpSp>
      <p:sp>
        <p:nvSpPr>
          <p:cNvPr id="36" name="Right Arrow 35"/>
          <p:cNvSpPr/>
          <p:nvPr/>
        </p:nvSpPr>
        <p:spPr>
          <a:xfrm rot="16200000">
            <a:off x="-296520" y="3709402"/>
            <a:ext cx="2316480" cy="24365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ight Arrow 36"/>
          <p:cNvSpPr/>
          <p:nvPr/>
        </p:nvSpPr>
        <p:spPr>
          <a:xfrm>
            <a:off x="2236412" y="9328988"/>
            <a:ext cx="2316480" cy="24365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82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7</TotalTime>
  <Words>41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E Raphael</dc:creator>
  <cp:lastModifiedBy>Claire E Raphael</cp:lastModifiedBy>
  <cp:revision>36</cp:revision>
  <dcterms:created xsi:type="dcterms:W3CDTF">2016-10-21T20:29:35Z</dcterms:created>
  <dcterms:modified xsi:type="dcterms:W3CDTF">2016-11-18T15:43:19Z</dcterms:modified>
</cp:coreProperties>
</file>